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77" r:id="rId2"/>
    <p:sldId id="257" r:id="rId3"/>
    <p:sldId id="258" r:id="rId4"/>
  </p:sldIdLst>
  <p:sldSz cx="9144000" cy="6858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CCFF"/>
    <a:srgbClr val="FFCC00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5" d="100"/>
          <a:sy n="125" d="100"/>
        </p:scale>
        <p:origin x="390" y="-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G\Desktop\temp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G\Desktop\temp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ko-KR"/>
              <a:t>Right</a:t>
            </a:r>
            <a:r>
              <a:rPr lang="en-US" altLang="ko-KR" baseline="0"/>
              <a:t> side of n</a:t>
            </a:r>
            <a:r>
              <a:rPr lang="en-US" altLang="ko-KR"/>
              <a:t>umer of nuclei</a:t>
            </a:r>
            <a:endParaRPr lang="ko-KR" altLang="en-US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13</c:f>
              <c:strCache>
                <c:ptCount val="1"/>
                <c:pt idx="0">
                  <c:v>wt_av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14:$E$14</c:f>
                <c:numCache>
                  <c:formatCode>General</c:formatCode>
                  <c:ptCount val="4"/>
                  <c:pt idx="0">
                    <c:v>4.0276819911981905</c:v>
                  </c:pt>
                  <c:pt idx="1">
                    <c:v>4.695151163109065</c:v>
                  </c:pt>
                  <c:pt idx="2">
                    <c:v>5.5537774932422783</c:v>
                  </c:pt>
                  <c:pt idx="3">
                    <c:v>7.1032074132433722</c:v>
                  </c:pt>
                </c:numCache>
              </c:numRef>
            </c:plus>
            <c:minus>
              <c:numRef>
                <c:f>Sheet1!$B$14:$E$14</c:f>
                <c:numCache>
                  <c:formatCode>General</c:formatCode>
                  <c:ptCount val="4"/>
                  <c:pt idx="0">
                    <c:v>4.0276819911981905</c:v>
                  </c:pt>
                  <c:pt idx="1">
                    <c:v>4.695151163109065</c:v>
                  </c:pt>
                  <c:pt idx="2">
                    <c:v>5.5537774932422783</c:v>
                  </c:pt>
                  <c:pt idx="3">
                    <c:v>7.10320741324337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13:$E$13</c:f>
              <c:numCache>
                <c:formatCode>General</c:formatCode>
                <c:ptCount val="4"/>
                <c:pt idx="0">
                  <c:v>19</c:v>
                </c:pt>
                <c:pt idx="1">
                  <c:v>20.6</c:v>
                </c:pt>
                <c:pt idx="2">
                  <c:v>21.8</c:v>
                </c:pt>
                <c:pt idx="3">
                  <c:v>21.7</c:v>
                </c:pt>
              </c:numCache>
            </c:numRef>
          </c:val>
        </c:ser>
        <c:ser>
          <c:idx val="1"/>
          <c:order val="1"/>
          <c:tx>
            <c:strRef>
              <c:f>Sheet1!$A$27</c:f>
              <c:strCache>
                <c:ptCount val="1"/>
                <c:pt idx="0">
                  <c:v>dlp_av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28:$E$28</c:f>
                <c:numCache>
                  <c:formatCode>General</c:formatCode>
                  <c:ptCount val="4"/>
                  <c:pt idx="0">
                    <c:v>3.1340424729448437</c:v>
                  </c:pt>
                  <c:pt idx="1">
                    <c:v>3.7252889522529307</c:v>
                  </c:pt>
                  <c:pt idx="2">
                    <c:v>4.0013886478460385</c:v>
                  </c:pt>
                  <c:pt idx="3">
                    <c:v>5.8698854806167722</c:v>
                  </c:pt>
                </c:numCache>
              </c:numRef>
            </c:plus>
            <c:minus>
              <c:numRef>
                <c:f>Sheet1!$B$28:$E$28</c:f>
                <c:numCache>
                  <c:formatCode>General</c:formatCode>
                  <c:ptCount val="4"/>
                  <c:pt idx="0">
                    <c:v>3.1340424729448437</c:v>
                  </c:pt>
                  <c:pt idx="1">
                    <c:v>3.7252889522529307</c:v>
                  </c:pt>
                  <c:pt idx="2">
                    <c:v>4.0013886478460385</c:v>
                  </c:pt>
                  <c:pt idx="3">
                    <c:v>5.86988548061677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27:$E$27</c:f>
              <c:numCache>
                <c:formatCode>General</c:formatCode>
                <c:ptCount val="4"/>
                <c:pt idx="0">
                  <c:v>19.600000000000001</c:v>
                </c:pt>
                <c:pt idx="1">
                  <c:v>21.1</c:v>
                </c:pt>
                <c:pt idx="2">
                  <c:v>20.3</c:v>
                </c:pt>
                <c:pt idx="3">
                  <c:v>21.3</c:v>
                </c:pt>
              </c:numCache>
            </c:numRef>
          </c:val>
        </c:ser>
        <c:ser>
          <c:idx val="2"/>
          <c:order val="2"/>
          <c:tx>
            <c:strRef>
              <c:f>Sheet1!$A$38</c:f>
              <c:strCache>
                <c:ptCount val="1"/>
                <c:pt idx="0">
                  <c:v>rescue_av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39:$E$39</c:f>
                <c:numCache>
                  <c:formatCode>General</c:formatCode>
                  <c:ptCount val="4"/>
                  <c:pt idx="0">
                    <c:v>1.9390719429665317</c:v>
                  </c:pt>
                  <c:pt idx="1">
                    <c:v>2.727636339397181</c:v>
                  </c:pt>
                  <c:pt idx="2">
                    <c:v>3.2619012860600263</c:v>
                  </c:pt>
                  <c:pt idx="3">
                    <c:v>3.1999999999999944</c:v>
                  </c:pt>
                </c:numCache>
              </c:numRef>
            </c:plus>
            <c:minus>
              <c:numRef>
                <c:f>Sheet1!$B$39:$E$39</c:f>
                <c:numCache>
                  <c:formatCode>General</c:formatCode>
                  <c:ptCount val="4"/>
                  <c:pt idx="0">
                    <c:v>1.9390719429665317</c:v>
                  </c:pt>
                  <c:pt idx="1">
                    <c:v>2.727636339397181</c:v>
                  </c:pt>
                  <c:pt idx="2">
                    <c:v>3.2619012860600263</c:v>
                  </c:pt>
                  <c:pt idx="3">
                    <c:v>3.19999999999999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38:$E$38</c:f>
              <c:numCache>
                <c:formatCode>General</c:formatCode>
                <c:ptCount val="4"/>
                <c:pt idx="0">
                  <c:v>19.2</c:v>
                </c:pt>
                <c:pt idx="1">
                  <c:v>20.6</c:v>
                </c:pt>
                <c:pt idx="2">
                  <c:v>20.6</c:v>
                </c:pt>
                <c:pt idx="3">
                  <c:v>21.4</c:v>
                </c:pt>
              </c:numCache>
            </c:numRef>
          </c:val>
        </c:ser>
        <c:ser>
          <c:idx val="3"/>
          <c:order val="3"/>
          <c:tx>
            <c:strRef>
              <c:f>Sheet1!$A$53</c:f>
              <c:strCache>
                <c:ptCount val="1"/>
                <c:pt idx="0">
                  <c:v>kash_av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54:$E$54</c:f>
                <c:numCache>
                  <c:formatCode>General</c:formatCode>
                  <c:ptCount val="4"/>
                  <c:pt idx="0">
                    <c:v>5.5387523665332576</c:v>
                  </c:pt>
                  <c:pt idx="1">
                    <c:v>5.0870205206759085</c:v>
                  </c:pt>
                  <c:pt idx="2">
                    <c:v>4.2804464979978647</c:v>
                  </c:pt>
                  <c:pt idx="3">
                    <c:v>5.5065617423417885</c:v>
                  </c:pt>
                </c:numCache>
              </c:numRef>
            </c:plus>
            <c:minus>
              <c:numRef>
                <c:f>Sheet1!$B$54:$E$54</c:f>
                <c:numCache>
                  <c:formatCode>General</c:formatCode>
                  <c:ptCount val="4"/>
                  <c:pt idx="0">
                    <c:v>5.5387523665332576</c:v>
                  </c:pt>
                  <c:pt idx="1">
                    <c:v>5.0870205206759085</c:v>
                  </c:pt>
                  <c:pt idx="2">
                    <c:v>4.2804464979978647</c:v>
                  </c:pt>
                  <c:pt idx="3">
                    <c:v>5.50656174234178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53:$E$53</c:f>
              <c:numCache>
                <c:formatCode>General</c:formatCode>
                <c:ptCount val="4"/>
                <c:pt idx="0">
                  <c:v>19.7</c:v>
                </c:pt>
                <c:pt idx="1">
                  <c:v>19.899999999999999</c:v>
                </c:pt>
                <c:pt idx="2">
                  <c:v>21.1</c:v>
                </c:pt>
                <c:pt idx="3">
                  <c:v>20.100000000000001</c:v>
                </c:pt>
              </c:numCache>
            </c:numRef>
          </c:val>
        </c:ser>
        <c:ser>
          <c:idx val="4"/>
          <c:order val="4"/>
          <c:tx>
            <c:strRef>
              <c:f>Sheet1!$A$69</c:f>
              <c:strCache>
                <c:ptCount val="1"/>
                <c:pt idx="0">
                  <c:v>zip_av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70:$E$70</c:f>
                <c:numCache>
                  <c:formatCode>General</c:formatCode>
                  <c:ptCount val="4"/>
                  <c:pt idx="0">
                    <c:v>7.4244341348160816</c:v>
                  </c:pt>
                  <c:pt idx="1">
                    <c:v>7.9309520235593434</c:v>
                  </c:pt>
                  <c:pt idx="2">
                    <c:v>7.4543052437277284</c:v>
                  </c:pt>
                  <c:pt idx="3">
                    <c:v>5.9637795622127676</c:v>
                  </c:pt>
                </c:numCache>
              </c:numRef>
            </c:plus>
            <c:minus>
              <c:numRef>
                <c:f>Sheet1!$B$70:$E$70</c:f>
                <c:numCache>
                  <c:formatCode>General</c:formatCode>
                  <c:ptCount val="4"/>
                  <c:pt idx="0">
                    <c:v>7.4244341348160816</c:v>
                  </c:pt>
                  <c:pt idx="1">
                    <c:v>7.9309520235593434</c:v>
                  </c:pt>
                  <c:pt idx="2">
                    <c:v>7.4543052437277284</c:v>
                  </c:pt>
                  <c:pt idx="3">
                    <c:v>5.96377956221276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69:$E$69</c:f>
              <c:numCache>
                <c:formatCode>General</c:formatCode>
                <c:ptCount val="4"/>
                <c:pt idx="0">
                  <c:v>19.7</c:v>
                </c:pt>
                <c:pt idx="1">
                  <c:v>20.3</c:v>
                </c:pt>
                <c:pt idx="2">
                  <c:v>20.3</c:v>
                </c:pt>
                <c:pt idx="3">
                  <c:v>21.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04515680"/>
        <c:axId val="1604505888"/>
      </c:barChart>
      <c:catAx>
        <c:axId val="160451568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4505888"/>
        <c:crosses val="autoZero"/>
        <c:auto val="1"/>
        <c:lblAlgn val="ctr"/>
        <c:lblOffset val="100"/>
        <c:noMultiLvlLbl val="0"/>
      </c:catAx>
      <c:valAx>
        <c:axId val="1604505888"/>
        <c:scaling>
          <c:orientation val="minMax"/>
          <c:max val="3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604515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1400" b="0" i="0" baseline="0">
                <a:effectLst/>
              </a:rPr>
              <a:t>Left side of numer of nuclei</a:t>
            </a:r>
            <a:endParaRPr lang="ko-KR" altLang="ko-KR" sz="1400">
              <a:effectLst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0" i="0" u="none" strike="noStrike" kern="1200" spc="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+mn-lt"/>
              <a:ea typeface="+mn-ea"/>
              <a:cs typeface="+mn-cs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G$13</c:f>
              <c:strCache>
                <c:ptCount val="1"/>
                <c:pt idx="0">
                  <c:v>wt_av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14:$K$14</c:f>
                <c:numCache>
                  <c:formatCode>General</c:formatCode>
                  <c:ptCount val="4"/>
                  <c:pt idx="0">
                    <c:v>5.2535702146254799</c:v>
                  </c:pt>
                  <c:pt idx="1">
                    <c:v>5.2715167541125085</c:v>
                  </c:pt>
                  <c:pt idx="2">
                    <c:v>3.3747427885527643</c:v>
                  </c:pt>
                  <c:pt idx="3">
                    <c:v>3.6530048514126672</c:v>
                  </c:pt>
                </c:numCache>
              </c:numRef>
            </c:plus>
            <c:minus>
              <c:numRef>
                <c:f>Sheet1!$H$14:$K$14</c:f>
                <c:numCache>
                  <c:formatCode>General</c:formatCode>
                  <c:ptCount val="4"/>
                  <c:pt idx="0">
                    <c:v>5.2535702146254799</c:v>
                  </c:pt>
                  <c:pt idx="1">
                    <c:v>5.2715167541125085</c:v>
                  </c:pt>
                  <c:pt idx="2">
                    <c:v>3.3747427885527643</c:v>
                  </c:pt>
                  <c:pt idx="3">
                    <c:v>3.65300485141266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H$13:$K$13</c:f>
              <c:numCache>
                <c:formatCode>General</c:formatCode>
                <c:ptCount val="4"/>
                <c:pt idx="0">
                  <c:v>18.600000000000001</c:v>
                </c:pt>
                <c:pt idx="1">
                  <c:v>19.7</c:v>
                </c:pt>
                <c:pt idx="2">
                  <c:v>19.5</c:v>
                </c:pt>
                <c:pt idx="3">
                  <c:v>20.3</c:v>
                </c:pt>
              </c:numCache>
            </c:numRef>
          </c:val>
        </c:ser>
        <c:ser>
          <c:idx val="1"/>
          <c:order val="1"/>
          <c:tx>
            <c:strRef>
              <c:f>Sheet1!$G$27</c:f>
              <c:strCache>
                <c:ptCount val="1"/>
                <c:pt idx="0">
                  <c:v>dlp_av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28:$K$28</c:f>
                <c:numCache>
                  <c:formatCode>General</c:formatCode>
                  <c:ptCount val="4"/>
                  <c:pt idx="0">
                    <c:v>3.8311588035185604</c:v>
                  </c:pt>
                  <c:pt idx="1">
                    <c:v>3.7490739597339973</c:v>
                  </c:pt>
                  <c:pt idx="2">
                    <c:v>3.8137179293236221</c:v>
                  </c:pt>
                  <c:pt idx="3">
                    <c:v>2.7968235951204061</c:v>
                  </c:pt>
                </c:numCache>
              </c:numRef>
            </c:plus>
            <c:minus>
              <c:numRef>
                <c:f>Sheet1!$H$28:$K$28</c:f>
                <c:numCache>
                  <c:formatCode>General</c:formatCode>
                  <c:ptCount val="4"/>
                  <c:pt idx="0">
                    <c:v>3.8311588035185604</c:v>
                  </c:pt>
                  <c:pt idx="1">
                    <c:v>3.7490739597339973</c:v>
                  </c:pt>
                  <c:pt idx="2">
                    <c:v>3.8137179293236221</c:v>
                  </c:pt>
                  <c:pt idx="3">
                    <c:v>2.79682359512040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H$27:$K$27</c:f>
              <c:numCache>
                <c:formatCode>General</c:formatCode>
                <c:ptCount val="4"/>
                <c:pt idx="0">
                  <c:v>18.3</c:v>
                </c:pt>
                <c:pt idx="1">
                  <c:v>17.5</c:v>
                </c:pt>
                <c:pt idx="2">
                  <c:v>18.899999999999999</c:v>
                </c:pt>
                <c:pt idx="3">
                  <c:v>19.399999999999999</c:v>
                </c:pt>
              </c:numCache>
            </c:numRef>
          </c:val>
        </c:ser>
        <c:ser>
          <c:idx val="2"/>
          <c:order val="2"/>
          <c:tx>
            <c:strRef>
              <c:f>Sheet1!$G$38</c:f>
              <c:strCache>
                <c:ptCount val="1"/>
                <c:pt idx="0">
                  <c:v>rescue_av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39:$K$39</c:f>
                <c:numCache>
                  <c:formatCode>General</c:formatCode>
                  <c:ptCount val="4"/>
                  <c:pt idx="0">
                    <c:v>1.6248076809271921</c:v>
                  </c:pt>
                  <c:pt idx="1">
                    <c:v>2.3151673805580333</c:v>
                  </c:pt>
                  <c:pt idx="2">
                    <c:v>2.6832815729997477</c:v>
                  </c:pt>
                  <c:pt idx="3">
                    <c:v>2.6381811916545908</c:v>
                  </c:pt>
                </c:numCache>
              </c:numRef>
            </c:plus>
            <c:minus>
              <c:numRef>
                <c:f>Sheet1!$H$39:$K$39</c:f>
                <c:numCache>
                  <c:formatCode>General</c:formatCode>
                  <c:ptCount val="4"/>
                  <c:pt idx="0">
                    <c:v>1.6248076809271921</c:v>
                  </c:pt>
                  <c:pt idx="1">
                    <c:v>2.3151673805580333</c:v>
                  </c:pt>
                  <c:pt idx="2">
                    <c:v>2.6832815729997477</c:v>
                  </c:pt>
                  <c:pt idx="3">
                    <c:v>2.63818119165459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H$38:$K$38</c:f>
              <c:numCache>
                <c:formatCode>General</c:formatCode>
                <c:ptCount val="4"/>
                <c:pt idx="0">
                  <c:v>19.600000000000001</c:v>
                </c:pt>
                <c:pt idx="1">
                  <c:v>19.2</c:v>
                </c:pt>
                <c:pt idx="2">
                  <c:v>19</c:v>
                </c:pt>
                <c:pt idx="3">
                  <c:v>20.8</c:v>
                </c:pt>
              </c:numCache>
            </c:numRef>
          </c:val>
        </c:ser>
        <c:ser>
          <c:idx val="3"/>
          <c:order val="3"/>
          <c:tx>
            <c:strRef>
              <c:f>Sheet1!$G$53</c:f>
              <c:strCache>
                <c:ptCount val="1"/>
                <c:pt idx="0">
                  <c:v>kash_av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54:$K$54</c:f>
                <c:numCache>
                  <c:formatCode>General</c:formatCode>
                  <c:ptCount val="4"/>
                  <c:pt idx="0">
                    <c:v>2.4585451886114389</c:v>
                  </c:pt>
                  <c:pt idx="1">
                    <c:v>3.4140233677518328</c:v>
                  </c:pt>
                  <c:pt idx="2">
                    <c:v>2.7507574714370326</c:v>
                  </c:pt>
                  <c:pt idx="3">
                    <c:v>5.216427044549854</c:v>
                  </c:pt>
                </c:numCache>
              </c:numRef>
            </c:plus>
            <c:minus>
              <c:numRef>
                <c:f>Sheet1!$H$54:$K$54</c:f>
                <c:numCache>
                  <c:formatCode>General</c:formatCode>
                  <c:ptCount val="4"/>
                  <c:pt idx="0">
                    <c:v>2.4585451886114389</c:v>
                  </c:pt>
                  <c:pt idx="1">
                    <c:v>3.4140233677518328</c:v>
                  </c:pt>
                  <c:pt idx="2">
                    <c:v>2.7507574714370326</c:v>
                  </c:pt>
                  <c:pt idx="3">
                    <c:v>5.2164270445498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H$53:$K$53</c:f>
              <c:numCache>
                <c:formatCode>General</c:formatCode>
                <c:ptCount val="4"/>
                <c:pt idx="0">
                  <c:v>17.399999999999999</c:v>
                </c:pt>
                <c:pt idx="1">
                  <c:v>18.100000000000001</c:v>
                </c:pt>
                <c:pt idx="2">
                  <c:v>18.3</c:v>
                </c:pt>
                <c:pt idx="3">
                  <c:v>20.100000000000001</c:v>
                </c:pt>
              </c:numCache>
            </c:numRef>
          </c:val>
        </c:ser>
        <c:ser>
          <c:idx val="4"/>
          <c:order val="4"/>
          <c:tx>
            <c:strRef>
              <c:f>Sheet1!$G$69</c:f>
              <c:strCache>
                <c:ptCount val="1"/>
                <c:pt idx="0">
                  <c:v>zip_av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70:$K$70</c:f>
                <c:numCache>
                  <c:formatCode>General</c:formatCode>
                  <c:ptCount val="4"/>
                  <c:pt idx="0">
                    <c:v>4.9933288829530689</c:v>
                  </c:pt>
                  <c:pt idx="1">
                    <c:v>5.1950831455222062</c:v>
                  </c:pt>
                  <c:pt idx="2">
                    <c:v>5.8271395689099084</c:v>
                  </c:pt>
                  <c:pt idx="3">
                    <c:v>6.7461923416925416</c:v>
                  </c:pt>
                </c:numCache>
              </c:numRef>
            </c:plus>
            <c:minus>
              <c:numRef>
                <c:f>Sheet1!$H$70:$K$70</c:f>
                <c:numCache>
                  <c:formatCode>General</c:formatCode>
                  <c:ptCount val="4"/>
                  <c:pt idx="0">
                    <c:v>4.9933288829530689</c:v>
                  </c:pt>
                  <c:pt idx="1">
                    <c:v>5.1950831455222062</c:v>
                  </c:pt>
                  <c:pt idx="2">
                    <c:v>5.8271395689099084</c:v>
                  </c:pt>
                  <c:pt idx="3">
                    <c:v>6.74619234169254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H$69:$K$69</c:f>
              <c:numCache>
                <c:formatCode>General</c:formatCode>
                <c:ptCount val="4"/>
                <c:pt idx="0">
                  <c:v>19.600000000000001</c:v>
                </c:pt>
                <c:pt idx="1">
                  <c:v>20.100000000000001</c:v>
                </c:pt>
                <c:pt idx="2">
                  <c:v>19.8</c:v>
                </c:pt>
                <c:pt idx="3">
                  <c:v>19.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04512416"/>
        <c:axId val="1604503168"/>
      </c:barChart>
      <c:catAx>
        <c:axId val="160451241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4503168"/>
        <c:crosses val="autoZero"/>
        <c:auto val="1"/>
        <c:lblAlgn val="ctr"/>
        <c:lblOffset val="100"/>
        <c:noMultiLvlLbl val="0"/>
      </c:catAx>
      <c:valAx>
        <c:axId val="16045031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6045124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880A8F-4FC2-41FF-B4C2-8D58EE080ABB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774ACA-4045-4B38-A841-6FCDC6BFC9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30118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46150" y="1349375"/>
            <a:ext cx="4854575" cy="3641725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ko-KR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movie) In the live embryos, it is difficult to detect the LR asymmetry of the nuclear rearrangement, </a:t>
            </a:r>
          </a:p>
          <a:p>
            <a:r>
              <a:rPr kumimoji="1" lang="en-US" altLang="ko-KR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cause the visceral muscles and their nuclei moves too actively to conduct a statistical analysis</a:t>
            </a:r>
            <a:endParaRPr kumimoji="1" lang="en-US" altLang="ko-KR" sz="1200" kern="1200" baseline="0" smtClean="0">
              <a:solidFill>
                <a:schemeClr val="tx1"/>
              </a:solidFill>
              <a:latin typeface="+mn-lt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B3BFE5F-CA7A-470E-9898-E661827C53C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8245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817AB-2C1A-4BC9-AF26-9936DB3C2A59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FFAF-7812-461D-839F-CC5E94C830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8298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817AB-2C1A-4BC9-AF26-9936DB3C2A59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FFAF-7812-461D-839F-CC5E94C830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4503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817AB-2C1A-4BC9-AF26-9936DB3C2A59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FFAF-7812-461D-839F-CC5E94C830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4244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817AB-2C1A-4BC9-AF26-9936DB3C2A59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FFAF-7812-461D-839F-CC5E94C830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4927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817AB-2C1A-4BC9-AF26-9936DB3C2A59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FFAF-7812-461D-839F-CC5E94C830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4682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817AB-2C1A-4BC9-AF26-9936DB3C2A59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FFAF-7812-461D-839F-CC5E94C830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0306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817AB-2C1A-4BC9-AF26-9936DB3C2A59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FFAF-7812-461D-839F-CC5E94C830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56715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817AB-2C1A-4BC9-AF26-9936DB3C2A59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FFAF-7812-461D-839F-CC5E94C830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7294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817AB-2C1A-4BC9-AF26-9936DB3C2A59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FFAF-7812-461D-839F-CC5E94C830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8055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817AB-2C1A-4BC9-AF26-9936DB3C2A59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FFAF-7812-461D-839F-CC5E94C830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4887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B817AB-2C1A-4BC9-AF26-9936DB3C2A59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90FFAF-7812-461D-839F-CC5E94C830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6657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B817AB-2C1A-4BC9-AF26-9936DB3C2A59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90FFAF-7812-461D-839F-CC5E94C830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7305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47"/>
          <p:cNvSpPr txBox="1"/>
          <p:nvPr/>
        </p:nvSpPr>
        <p:spPr>
          <a:xfrm>
            <a:off x="0" y="-3493"/>
            <a:ext cx="914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3600">
                <a:latin typeface="+mj-lt"/>
                <a:ea typeface="Arial Unicode MS" panose="020B0604020202020204" pitchFamily="50" charset="-127"/>
                <a:cs typeface="Arial Unicode MS" panose="020B0604020202020204" pitchFamily="50" charset="-127"/>
              </a:rPr>
              <a:t>Graph 1. Number of nuclei</a:t>
            </a:r>
            <a:endParaRPr lang="en-US" altLang="ko-KR" sz="3600">
              <a:latin typeface="+mj-lt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aphicFrame>
        <p:nvGraphicFramePr>
          <p:cNvPr id="6" name="차트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827374"/>
              </p:ext>
            </p:extLst>
          </p:nvPr>
        </p:nvGraphicFramePr>
        <p:xfrm>
          <a:off x="4572000" y="183497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차트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3136109"/>
              </p:ext>
            </p:extLst>
          </p:nvPr>
        </p:nvGraphicFramePr>
        <p:xfrm>
          <a:off x="82378" y="183497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" name="직사각형 10"/>
          <p:cNvSpPr/>
          <p:nvPr/>
        </p:nvSpPr>
        <p:spPr>
          <a:xfrm>
            <a:off x="2358544" y="4852190"/>
            <a:ext cx="4194655" cy="2975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1600"/>
              </a:lnSpc>
            </a:pPr>
            <a:r>
              <a:rPr lang="en-US" altLang="ko-KR" sz="24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■       </a:t>
            </a:r>
            <a:r>
              <a:rPr lang="en-US" altLang="ko-KR" sz="1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   </a:t>
            </a:r>
            <a:r>
              <a:rPr lang="en-US" altLang="ko-KR" sz="2400" smtClean="0">
                <a:solidFill>
                  <a:srgbClr val="FF0000"/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■    </a:t>
            </a:r>
            <a:r>
              <a:rPr lang="en-US" altLang="ko-KR" sz="8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2400" smtClean="0">
                <a:solidFill>
                  <a:srgbClr val="92D050"/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■         </a:t>
            </a:r>
            <a:r>
              <a:rPr lang="en-US" altLang="ko-KR" sz="8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2400" smtClean="0">
                <a:solidFill>
                  <a:srgbClr val="FFCC00"/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■         </a:t>
            </a:r>
            <a:r>
              <a:rPr lang="en-US" altLang="ko-KR" sz="8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</a:t>
            </a:r>
            <a:r>
              <a:rPr lang="en-US" altLang="ko-KR" sz="2400" smtClean="0">
                <a:solidFill>
                  <a:srgbClr val="33CCFF"/>
                </a:solidFill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■</a:t>
            </a:r>
            <a:endParaRPr lang="ko-KR" altLang="en-US" sz="24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6" name="직사각형 15"/>
          <p:cNvSpPr/>
          <p:nvPr/>
        </p:nvSpPr>
        <p:spPr>
          <a:xfrm>
            <a:off x="5874598" y="4811244"/>
            <a:ext cx="58348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i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zip</a:t>
            </a:r>
            <a:r>
              <a:rPr lang="en-US" altLang="ja-JP" sz="900" i="1" baseline="300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</a:t>
            </a:r>
            <a:endParaRPr lang="en-US" altLang="ko-KR" sz="90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7" name="직사각형 16"/>
          <p:cNvSpPr/>
          <p:nvPr/>
        </p:nvSpPr>
        <p:spPr>
          <a:xfrm>
            <a:off x="2556537" y="4811244"/>
            <a:ext cx="63350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9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wild type</a:t>
            </a:r>
          </a:p>
        </p:txBody>
      </p:sp>
      <p:sp>
        <p:nvSpPr>
          <p:cNvPr id="18" name="직사각형 17"/>
          <p:cNvSpPr/>
          <p:nvPr/>
        </p:nvSpPr>
        <p:spPr>
          <a:xfrm>
            <a:off x="4849349" y="4811244"/>
            <a:ext cx="87418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900" i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sp300</a:t>
            </a:r>
            <a:r>
              <a:rPr lang="en-US" altLang="ja-JP" sz="900" i="1" baseline="30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△</a:t>
            </a:r>
            <a:r>
              <a:rPr lang="en-US" altLang="ja-JP" sz="900" i="1" baseline="300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KASH</a:t>
            </a:r>
            <a:endParaRPr lang="en-US" altLang="ko-KR" sz="90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2" name="직사각형 21"/>
          <p:cNvSpPr/>
          <p:nvPr/>
        </p:nvSpPr>
        <p:spPr>
          <a:xfrm>
            <a:off x="762697" y="4449229"/>
            <a:ext cx="341632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9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1      </a:t>
            </a:r>
            <a:r>
              <a:rPr lang="en-US" altLang="ko-KR" sz="9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              T2                            </a:t>
            </a:r>
            <a:r>
              <a:rPr lang="en-US" altLang="ko-KR" sz="9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3      </a:t>
            </a:r>
            <a:r>
              <a:rPr lang="en-US" altLang="ko-KR" sz="9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               T4</a:t>
            </a:r>
            <a:endParaRPr lang="en-US" altLang="ko-KR" sz="90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6" name="직사각형 25"/>
          <p:cNvSpPr/>
          <p:nvPr/>
        </p:nvSpPr>
        <p:spPr>
          <a:xfrm>
            <a:off x="3341112" y="4811244"/>
            <a:ext cx="38183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900" i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lp</a:t>
            </a:r>
            <a:r>
              <a:rPr lang="en-US" altLang="ko-KR" sz="900" i="1" baseline="30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endParaRPr lang="en-US" altLang="ko-KR" sz="90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7" name="직사각형 26"/>
          <p:cNvSpPr/>
          <p:nvPr/>
        </p:nvSpPr>
        <p:spPr>
          <a:xfrm>
            <a:off x="3874016" y="4811244"/>
            <a:ext cx="82426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900" i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lp</a:t>
            </a:r>
            <a:r>
              <a:rPr lang="en-US" altLang="ko-KR" sz="900" i="1" baseline="30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3</a:t>
            </a:r>
            <a:r>
              <a:rPr lang="en-US" altLang="ko-KR" sz="9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rescued</a:t>
            </a:r>
          </a:p>
        </p:txBody>
      </p:sp>
      <p:sp>
        <p:nvSpPr>
          <p:cNvPr id="30" name="직사각형 29"/>
          <p:cNvSpPr/>
          <p:nvPr/>
        </p:nvSpPr>
        <p:spPr>
          <a:xfrm>
            <a:off x="5241987" y="4435632"/>
            <a:ext cx="341632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9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1      </a:t>
            </a:r>
            <a:r>
              <a:rPr lang="en-US" altLang="ko-KR" sz="9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              T2                            </a:t>
            </a:r>
            <a:r>
              <a:rPr lang="en-US" altLang="ko-KR" sz="9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3      </a:t>
            </a:r>
            <a:r>
              <a:rPr lang="en-US" altLang="ko-KR" sz="9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               T4</a:t>
            </a:r>
            <a:endParaRPr lang="en-US" altLang="ko-KR" sz="90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814502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0" y="1439226"/>
            <a:ext cx="7559675" cy="51706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# </a:t>
            </a:r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Usage - select nuclei and execute this script</a:t>
            </a:r>
          </a:p>
          <a:p>
            <a:endParaRPr lang="en-US" altLang="ko-KR" sz="10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mport maya.cmds as cmds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mport math as math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mport numpy as np</a:t>
            </a:r>
          </a:p>
          <a:p>
            <a:endParaRPr lang="en-US" altLang="ko-KR" sz="10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td_list = []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o_midline = []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al_by_curve = []</a:t>
            </a:r>
          </a:p>
          <a:p>
            <a:endParaRPr lang="en-US" altLang="ko-KR" sz="10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"\n&gt;&gt;&gt;start&lt;&lt;&lt;\n"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width_ = 150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# now width of embryo is 150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el_ = cmds.ls(sl=1)</a:t>
            </a:r>
          </a:p>
          <a:p>
            <a:endParaRPr lang="en-US" altLang="ko-KR" sz="10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or serial in sel_: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XYZ = cmds.objectCenter(serial, gl=True)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# getting the center of nucleus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middd = [0, 0, 0]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list_XZ = XYZ[0], XYZ[2]</a:t>
            </a:r>
          </a:p>
          <a:p>
            <a:endParaRPr lang="en-US" altLang="ko-KR" sz="10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dx = 0 - XYZ[0]</a:t>
            </a:r>
          </a:p>
          <a:p>
            <a:r>
              <a:rPr lang="en-US" altLang="ko-KR" sz="10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dz = 0 - XYZ[2]	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dis_to_cent = math.sqrt((dx*dx)+(dz*dz))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print "nucleus =", serial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print "real distance to midline =", dis_to_cent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middd[1] = XYZ[1]</a:t>
            </a:r>
          </a:p>
          <a:p>
            <a:endParaRPr lang="en-US" altLang="ko-KR" sz="10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endParaRPr lang="en-US" altLang="ko-KR" sz="10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0" y="0"/>
            <a:ext cx="9144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600" smtClean="0">
                <a:latin typeface="+mj-lt"/>
                <a:ea typeface="Arial Unicode MS" panose="020B0604020202020204" pitchFamily="50" charset="-127"/>
                <a:cs typeface="Arial Unicode MS" panose="020B0604020202020204" pitchFamily="50" charset="-127"/>
              </a:rPr>
              <a:t>Script </a:t>
            </a:r>
            <a:r>
              <a:rPr lang="en-US" altLang="ja-JP" sz="3600" smtClean="0">
                <a:latin typeface="+mj-lt"/>
                <a:ea typeface="Arial Unicode MS" panose="020B0604020202020204" pitchFamily="50" charset="-127"/>
                <a:cs typeface="Arial Unicode MS" panose="020B0604020202020204" pitchFamily="50" charset="-127"/>
              </a:rPr>
              <a:t>1. </a:t>
            </a:r>
            <a:r>
              <a:rPr lang="en-US" altLang="ja-JP" sz="3600">
                <a:latin typeface="+mj-lt"/>
                <a:ea typeface="Arial Unicode MS" panose="020B0604020202020204" pitchFamily="50" charset="-127"/>
                <a:cs typeface="Arial Unicode MS" panose="020B0604020202020204" pitchFamily="50" charset="-127"/>
              </a:rPr>
              <a:t>measures the average distance between nuclei and </a:t>
            </a:r>
            <a:r>
              <a:rPr lang="en-US" altLang="ja-JP" sz="3600">
                <a:latin typeface="+mj-lt"/>
                <a:ea typeface="Arial Unicode MS" panose="020B0604020202020204" pitchFamily="50" charset="-127"/>
                <a:cs typeface="Arial Unicode MS" panose="020B0604020202020204" pitchFamily="50" charset="-127"/>
              </a:rPr>
              <a:t>the </a:t>
            </a:r>
            <a:r>
              <a:rPr lang="en-US" altLang="ja-JP" sz="3600" smtClean="0">
                <a:latin typeface="+mj-lt"/>
                <a:ea typeface="Arial Unicode MS" panose="020B0604020202020204" pitchFamily="50" charset="-127"/>
                <a:cs typeface="Arial Unicode MS" panose="020B0604020202020204" pitchFamily="50" charset="-127"/>
              </a:rPr>
              <a:t>midline.</a:t>
            </a:r>
            <a:endParaRPr lang="en-US" altLang="ja-JP" sz="3600">
              <a:latin typeface="+mj-lt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4415482" y="1544686"/>
            <a:ext cx="4552950" cy="45550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altLang="ko-KR" sz="10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</a:t>
            </a:r>
            <a:r>
              <a:rPr lang="en-US" altLang="ko-KR" sz="10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o_midline.append(XYZ</a:t>
            </a:r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)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to_midline.append(middd)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print "coordinate of nucleus and midline =", to_midline	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cc = cmds.curve(d=1,p=to_midline)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print "recheck length by line", (cmds.arclen(cc))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ratio_ = (dis_to_cent / width_) * 100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print "distance as ratio =", ratio_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std_list.append(ratio_)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ratio_by_curve = ((cmds.arclen(cc) / width_)) * 100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cal_by_curve.append(ratio_by_curve)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del to_midline[:]	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ean_ = np.mean(std_list)  #calculate mean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td_ = np.std(std_list)    #calculate standard deviation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ean_curve = np.mean(cal_by_curve)  #calculate mean by line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td_curve  = np.std(cal_by_curve)   #calculate standard deviation by line</a:t>
            </a:r>
          </a:p>
          <a:p>
            <a:endParaRPr lang="en-US" altLang="ko-KR" sz="10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"\n&lt;result&gt;\n"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"width of embryo =\n", width_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"number of connections =\n", len(sel_)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"mean of connectiones =\n", mean_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"standard deviation =\n", std_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"mean of connectiones (by line) =\n", mean_curve</a:t>
            </a:r>
          </a:p>
          <a:p>
            <a:r>
              <a:rPr lang="en-US" altLang="ko-KR" sz="10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"standard deviation (by line) =\n", std_curve</a:t>
            </a:r>
          </a:p>
        </p:txBody>
      </p:sp>
      <p:cxnSp>
        <p:nvCxnSpPr>
          <p:cNvPr id="3" name="직선 연결선 2"/>
          <p:cNvCxnSpPr/>
          <p:nvPr/>
        </p:nvCxnSpPr>
        <p:spPr>
          <a:xfrm>
            <a:off x="4216400" y="1200329"/>
            <a:ext cx="0" cy="541234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직사각형 7"/>
          <p:cNvSpPr/>
          <p:nvPr/>
        </p:nvSpPr>
        <p:spPr>
          <a:xfrm>
            <a:off x="1544630" y="6443484"/>
            <a:ext cx="52229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mtClean="0">
                <a:ea typeface="Arial Unicode MS" panose="020B0604020202020204" pitchFamily="50" charset="-127"/>
                <a:cs typeface="Arial Unicode MS" panose="020B0604020202020204" pitchFamily="50" charset="-127"/>
              </a:rPr>
              <a:t>1/2       </a:t>
            </a:r>
            <a:r>
              <a:rPr lang="en-US" altLang="ko-KR" smtClean="0"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                                                                    2/2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50449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직사각형 5"/>
          <p:cNvSpPr/>
          <p:nvPr/>
        </p:nvSpPr>
        <p:spPr>
          <a:xfrm>
            <a:off x="0" y="1381565"/>
            <a:ext cx="7559675" cy="39857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ko-KR" altLang="en-US" sz="11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# </a:t>
            </a:r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Usage - select nuclei and execute this script</a:t>
            </a:r>
          </a:p>
          <a:p>
            <a:endParaRPr lang="ko-KR" altLang="en-US" sz="11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mport maya.cmds as cmds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mport numpy as np</a:t>
            </a:r>
          </a:p>
          <a:p>
            <a:endParaRPr lang="ko-KR" altLang="en-US" sz="11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"\n&gt;&gt;&gt;start&lt;&lt;&lt;\n"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width_ = 107.94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#now width of embryo is 107.94</a:t>
            </a:r>
          </a:p>
          <a:p>
            <a:endParaRPr lang="ko-KR" altLang="en-US" sz="11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el_ = cmds.ls(sl=1)</a:t>
            </a:r>
          </a:p>
          <a:p>
            <a:endParaRPr lang="ko-KR" altLang="en-US" sz="11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os_ = []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urves_ = []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or serial in sel_: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XYZ = cmds.objectCenter(serial, gl=True)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#calculate center of nucleus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print "coordinate of", serial, XYZ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	pos_.append(XYZ)</a:t>
            </a:r>
          </a:p>
          <a:p>
            <a:endParaRPr lang="ko-KR" altLang="en-US" sz="11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ort = sorted(pos_, key=lambda pos_: pos_[1])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#in case of ‘pos_[1]’, nearest nuclei are connect along Y axis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#if case of ‘pos_[0]’, nuclei are connect along X axis 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#and ‘pos_[2]’, nearest nuclei are connect along Z </a:t>
            </a:r>
            <a:r>
              <a:rPr lang="ko-KR" altLang="en-US" sz="11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xis</a:t>
            </a:r>
            <a:endParaRPr lang="ko-KR" altLang="en-US" sz="110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0" y="0"/>
            <a:ext cx="9144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600" smtClean="0">
                <a:latin typeface="+mj-lt"/>
                <a:ea typeface="Arial Unicode MS" panose="020B0604020202020204" pitchFamily="50" charset="-127"/>
                <a:cs typeface="Arial Unicode MS" panose="020B0604020202020204" pitchFamily="50" charset="-127"/>
              </a:rPr>
              <a:t>Script </a:t>
            </a:r>
            <a:r>
              <a:rPr lang="en-US" altLang="ja-JP" sz="3600">
                <a:latin typeface="+mj-lt"/>
                <a:ea typeface="Arial Unicode MS" panose="020B0604020202020204" pitchFamily="50" charset="-127"/>
                <a:cs typeface="Arial Unicode MS" panose="020B0604020202020204" pitchFamily="50" charset="-127"/>
              </a:rPr>
              <a:t>2. calculates the collectivity of </a:t>
            </a:r>
            <a:r>
              <a:rPr lang="en-US" altLang="ja-JP" sz="3600">
                <a:latin typeface="+mj-lt"/>
                <a:ea typeface="Arial Unicode MS" panose="020B0604020202020204" pitchFamily="50" charset="-127"/>
                <a:cs typeface="Arial Unicode MS" panose="020B0604020202020204" pitchFamily="50" charset="-127"/>
              </a:rPr>
              <a:t>nuclear </a:t>
            </a:r>
            <a:endParaRPr lang="en-US" altLang="ja-JP" sz="3600" smtClean="0">
              <a:latin typeface="+mj-lt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r>
              <a:rPr lang="en-US" altLang="ja-JP" sz="3600" smtClean="0">
                <a:latin typeface="+mj-lt"/>
                <a:ea typeface="Arial Unicode MS" panose="020B0604020202020204" pitchFamily="50" charset="-127"/>
                <a:cs typeface="Arial Unicode MS" panose="020B0604020202020204" pitchFamily="50" charset="-127"/>
              </a:rPr>
              <a:t>arrangement</a:t>
            </a:r>
            <a:r>
              <a:rPr lang="en-US" altLang="ja-JP" sz="3600">
                <a:latin typeface="+mj-lt"/>
                <a:ea typeface="Arial Unicode MS" panose="020B0604020202020204" pitchFamily="50" charset="-127"/>
                <a:cs typeface="Arial Unicode MS" panose="020B0604020202020204" pitchFamily="50" charset="-127"/>
              </a:rPr>
              <a:t>.</a:t>
            </a:r>
            <a:endParaRPr lang="en-US" altLang="ja-JP" sz="3600">
              <a:latin typeface="+mj-lt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cxnSp>
        <p:nvCxnSpPr>
          <p:cNvPr id="4" name="직선 연결선 3"/>
          <p:cNvCxnSpPr/>
          <p:nvPr/>
        </p:nvCxnSpPr>
        <p:spPr>
          <a:xfrm>
            <a:off x="4216400" y="1200329"/>
            <a:ext cx="0" cy="541234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직사각형 4"/>
          <p:cNvSpPr/>
          <p:nvPr/>
        </p:nvSpPr>
        <p:spPr>
          <a:xfrm>
            <a:off x="4740275" y="1381565"/>
            <a:ext cx="4491037" cy="48320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ko-KR" altLang="en-US" sz="11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</a:t>
            </a:r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"sorted\n", sort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c = cmds.curve(d=1,p=sort)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"length of total distance = "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cmds.arclen(cc)	</a:t>
            </a:r>
          </a:p>
          <a:p>
            <a:r>
              <a:rPr lang="ko-KR" altLang="en-US" sz="11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"number of connections = "</a:t>
            </a:r>
          </a:p>
          <a:p>
            <a:r>
              <a:rPr lang="ko-KR" altLang="en-US" sz="110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i </a:t>
            </a:r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= (len(sort)) - 1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ii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or i in range(0,len(sort)):    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if i &lt; ii: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a = np.array(sort[i])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b = np.array(sort[i+1])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dist = np.linalg.norm(a-b)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#real distance        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ratio__ = (dist / width__) * 100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#real distance is changed as ratio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print "nucleus #", i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print "real distance =", dist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print "ratio =", ratio__        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curves_.append(ratio__)        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else: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print "\n&lt;result&gt;\n"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"length of each distances=\n", curves_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ean_ = np.mean(curves_)  #calculate mean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td_ = np.std(curves_)    #calculate standard deviation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"width of embryo =\n", width_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"number of connections =\n", len(sel_)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"mean of connectiones =\n", mean_</a:t>
            </a:r>
          </a:p>
          <a:p>
            <a:r>
              <a:rPr lang="ko-KR" altLang="en-US" sz="11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int "standard deviation =\n", std_</a:t>
            </a:r>
          </a:p>
        </p:txBody>
      </p:sp>
      <p:sp>
        <p:nvSpPr>
          <p:cNvPr id="9" name="직사각형 8"/>
          <p:cNvSpPr/>
          <p:nvPr/>
        </p:nvSpPr>
        <p:spPr>
          <a:xfrm>
            <a:off x="1544630" y="6443484"/>
            <a:ext cx="52229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mtClean="0">
                <a:ea typeface="Arial Unicode MS" panose="020B0604020202020204" pitchFamily="50" charset="-127"/>
                <a:cs typeface="Arial Unicode MS" panose="020B0604020202020204" pitchFamily="50" charset="-127"/>
              </a:rPr>
              <a:t>1/2       </a:t>
            </a:r>
            <a:r>
              <a:rPr lang="en-US" altLang="ko-KR" smtClean="0">
                <a:ea typeface="Arial Unicode MS" panose="020B0604020202020204" pitchFamily="50" charset="-127"/>
                <a:cs typeface="Arial Unicode MS" panose="020B0604020202020204" pitchFamily="50" charset="-127"/>
              </a:rPr>
              <a:t>                                                                            2/2</a:t>
            </a:r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33171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14</TotalTime>
  <Words>237</Words>
  <Application>Microsoft Office PowerPoint</Application>
  <PresentationFormat>화면 슬라이드 쇼(4:3)</PresentationFormat>
  <Paragraphs>128</Paragraphs>
  <Slides>3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10" baseType="lpstr">
      <vt:lpstr>Arial Unicode MS</vt:lpstr>
      <vt:lpstr>ＭＳ Ｐゴシック</vt:lpstr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G</dc:creator>
  <cp:lastModifiedBy>LG</cp:lastModifiedBy>
  <cp:revision>79</cp:revision>
  <cp:lastPrinted>2020-08-29T03:29:13Z</cp:lastPrinted>
  <dcterms:created xsi:type="dcterms:W3CDTF">2020-07-31T06:01:28Z</dcterms:created>
  <dcterms:modified xsi:type="dcterms:W3CDTF">2020-10-14T02:35:13Z</dcterms:modified>
</cp:coreProperties>
</file>